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110" d="100"/>
          <a:sy n="110" d="100"/>
        </p:scale>
        <p:origin x="-924" y="-12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 smtClean="0"/>
              <a:t>Cliquez pour modifier le style des sous-titres du masque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9EF62A-B9B3-491D-AEB9-A8C3BAAA487B}" type="datetimeFigureOut">
              <a:rPr lang="fr-FR" smtClean="0"/>
              <a:t>07/07/2016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4DB7AF-167E-4490-8FEA-190D9F324909}" type="slidenum">
              <a:rPr lang="fr-FR" smtClean="0"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9EF62A-B9B3-491D-AEB9-A8C3BAAA487B}" type="datetimeFigureOut">
              <a:rPr lang="fr-FR" smtClean="0"/>
              <a:t>07/07/2016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4DB7AF-167E-4490-8FEA-190D9F324909}" type="slidenum">
              <a:rPr lang="fr-FR" smtClean="0"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9EF62A-B9B3-491D-AEB9-A8C3BAAA487B}" type="datetimeFigureOut">
              <a:rPr lang="fr-FR" smtClean="0"/>
              <a:t>07/07/2016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4DB7AF-167E-4490-8FEA-190D9F324909}" type="slidenum">
              <a:rPr lang="fr-FR" smtClean="0"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9EF62A-B9B3-491D-AEB9-A8C3BAAA487B}" type="datetimeFigureOut">
              <a:rPr lang="fr-FR" smtClean="0"/>
              <a:t>07/07/2016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4DB7AF-167E-4490-8FEA-190D9F324909}" type="slidenum">
              <a:rPr lang="fr-FR" smtClean="0"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9EF62A-B9B3-491D-AEB9-A8C3BAAA487B}" type="datetimeFigureOut">
              <a:rPr lang="fr-FR" smtClean="0"/>
              <a:t>07/07/2016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4DB7AF-167E-4490-8FEA-190D9F324909}" type="slidenum">
              <a:rPr lang="fr-FR" smtClean="0"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9EF62A-B9B3-491D-AEB9-A8C3BAAA487B}" type="datetimeFigureOut">
              <a:rPr lang="fr-FR" smtClean="0"/>
              <a:t>07/07/2016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4DB7AF-167E-4490-8FEA-190D9F324909}" type="slidenum">
              <a:rPr lang="fr-FR" smtClean="0"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9EF62A-B9B3-491D-AEB9-A8C3BAAA487B}" type="datetimeFigureOut">
              <a:rPr lang="fr-FR" smtClean="0"/>
              <a:t>07/07/2016</a:t>
            </a:fld>
            <a:endParaRPr lang="fr-FR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4DB7AF-167E-4490-8FEA-190D9F324909}" type="slidenum">
              <a:rPr lang="fr-FR" smtClean="0"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9EF62A-B9B3-491D-AEB9-A8C3BAAA487B}" type="datetimeFigureOut">
              <a:rPr lang="fr-FR" smtClean="0"/>
              <a:t>07/07/2016</a:t>
            </a:fld>
            <a:endParaRPr lang="fr-FR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4DB7AF-167E-4490-8FEA-190D9F324909}" type="slidenum">
              <a:rPr lang="fr-FR" smtClean="0"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9EF62A-B9B3-491D-AEB9-A8C3BAAA487B}" type="datetimeFigureOut">
              <a:rPr lang="fr-FR" smtClean="0"/>
              <a:t>07/07/2016</a:t>
            </a:fld>
            <a:endParaRPr lang="fr-FR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4DB7AF-167E-4490-8FEA-190D9F324909}" type="slidenum">
              <a:rPr lang="fr-FR" smtClean="0"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9EF62A-B9B3-491D-AEB9-A8C3BAAA487B}" type="datetimeFigureOut">
              <a:rPr lang="fr-FR" smtClean="0"/>
              <a:t>07/07/2016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4DB7AF-167E-4490-8FEA-190D9F324909}" type="slidenum">
              <a:rPr lang="fr-FR" smtClean="0"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pour une image 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9EF62A-B9B3-491D-AEB9-A8C3BAAA487B}" type="datetimeFigureOut">
              <a:rPr lang="fr-FR" smtClean="0"/>
              <a:t>07/07/2016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4DB7AF-167E-4490-8FEA-190D9F324909}" type="slidenum">
              <a:rPr lang="fr-FR" smtClean="0"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89EF62A-B9B3-491D-AEB9-A8C3BAAA487B}" type="datetimeFigureOut">
              <a:rPr lang="fr-FR" smtClean="0"/>
              <a:t>07/07/2016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84DB7AF-167E-4490-8FEA-190D9F324909}" type="slidenum">
              <a:rPr lang="fr-FR" smtClean="0"/>
              <a:t>‹N°›</a:t>
            </a:fld>
            <a:endParaRPr lang="fr-FR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3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ZoneTexte 3"/>
          <p:cNvSpPr txBox="1"/>
          <p:nvPr/>
        </p:nvSpPr>
        <p:spPr>
          <a:xfrm>
            <a:off x="251520" y="6002704"/>
            <a:ext cx="8640960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fr-FR" sz="11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</a:t>
            </a:r>
            <a:r>
              <a:rPr lang="fr-FR" sz="11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Fig. </a:t>
            </a:r>
            <a:r>
              <a:rPr lang="fr-FR" sz="1100" b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3</a:t>
            </a:r>
            <a:r>
              <a:rPr lang="fr-FR" sz="110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fr-FR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dentification of </a:t>
            </a:r>
            <a:r>
              <a:rPr lang="fr-FR" sz="11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eature</a:t>
            </a:r>
            <a:r>
              <a:rPr lang="fr-FR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M137T29 as 1-méthylnicotinamide (cas 1005-24-9); </a:t>
            </a:r>
            <a:r>
              <a:rPr lang="fr-FR" sz="11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red</a:t>
            </a:r>
            <a:r>
              <a:rPr lang="fr-FR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fr-FR" sz="11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lines</a:t>
            </a:r>
            <a:r>
              <a:rPr lang="fr-FR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: standard </a:t>
            </a:r>
            <a:r>
              <a:rPr lang="fr-FR" sz="11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olecule</a:t>
            </a:r>
            <a:r>
              <a:rPr lang="fr-FR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; </a:t>
            </a:r>
            <a:r>
              <a:rPr lang="fr-FR" sz="11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lue</a:t>
            </a:r>
            <a:r>
              <a:rPr lang="fr-FR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fr-FR" sz="11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lines</a:t>
            </a:r>
            <a:r>
              <a:rPr lang="fr-FR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, </a:t>
            </a:r>
            <a:r>
              <a:rPr lang="fr-FR" sz="11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experimental</a:t>
            </a:r>
            <a:r>
              <a:rPr lang="fr-FR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fr-FR" sz="11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ample</a:t>
            </a:r>
            <a:r>
              <a:rPr lang="fr-FR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fr-FR" sz="11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op</a:t>
            </a:r>
            <a:r>
              <a:rPr lang="fr-FR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Full MS </a:t>
            </a:r>
            <a:r>
              <a:rPr lang="fr-FR" sz="11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hromatograms</a:t>
            </a:r>
            <a:r>
              <a:rPr lang="fr-FR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fr-FR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M</a:t>
            </a:r>
            <a:r>
              <a:rPr lang="fr-FR" sz="11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ddle</a:t>
            </a:r>
            <a:r>
              <a:rPr lang="fr-FR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Full MS </a:t>
            </a:r>
            <a:r>
              <a:rPr lang="fr-FR" sz="11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pectra</a:t>
            </a:r>
            <a:r>
              <a:rPr lang="fr-FR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fr-FR" sz="11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ottom</a:t>
            </a:r>
            <a:r>
              <a:rPr lang="fr-FR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MS/MS </a:t>
            </a:r>
            <a:r>
              <a:rPr lang="fr-FR" sz="11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pectra</a:t>
            </a:r>
            <a:endParaRPr lang="fr-FR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5" name="Picture 6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1196150" y="2277072"/>
            <a:ext cx="6751700" cy="1800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6" name="Picture 7"/>
          <p:cNvPicPr>
            <a:picLocks noChangeAspect="1" noChangeArrowheads="1"/>
          </p:cNvPicPr>
          <p:nvPr/>
        </p:nvPicPr>
        <p:blipFill>
          <a:blip r:embed="rId3" cstate="print"/>
          <a:srcRect/>
          <a:stretch>
            <a:fillRect/>
          </a:stretch>
        </p:blipFill>
        <p:spPr bwMode="auto">
          <a:xfrm>
            <a:off x="1196150" y="260848"/>
            <a:ext cx="6751700" cy="1800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7" name="Picture 2"/>
          <p:cNvPicPr>
            <a:picLocks noChangeAspect="1" noChangeArrowheads="1"/>
          </p:cNvPicPr>
          <p:nvPr/>
        </p:nvPicPr>
        <p:blipFill>
          <a:blip r:embed="rId4" cstate="print"/>
          <a:srcRect/>
          <a:stretch>
            <a:fillRect/>
          </a:stretch>
        </p:blipFill>
        <p:spPr bwMode="auto">
          <a:xfrm>
            <a:off x="1196175" y="4149280"/>
            <a:ext cx="6751650" cy="1800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0</TotalTime>
  <Words>39</Words>
  <Application>Microsoft Office PowerPoint</Application>
  <PresentationFormat>Affichage à l'écran (4:3)</PresentationFormat>
  <Paragraphs>1</Paragraphs>
  <Slides>1</Slides>
  <Notes>0</Notes>
  <HiddenSlides>0</HiddenSlides>
  <MMClips>0</MMClips>
  <ScaleCrop>false</ScaleCrop>
  <HeadingPairs>
    <vt:vector size="4" baseType="variant"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2" baseType="lpstr">
      <vt:lpstr>Thème Office</vt:lpstr>
      <vt:lpstr>Présentation PowerPoint</vt:lpstr>
    </vt:vector>
  </TitlesOfParts>
  <Company>Microsoft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iapositive 1</dc:title>
  <dc:creator>Gaelle</dc:creator>
  <cp:lastModifiedBy>GRISON Stephane</cp:lastModifiedBy>
  <cp:revision>6</cp:revision>
  <dcterms:created xsi:type="dcterms:W3CDTF">2014-11-17T10:21:09Z</dcterms:created>
  <dcterms:modified xsi:type="dcterms:W3CDTF">2016-07-07T13:30:39Z</dcterms:modified>
</cp:coreProperties>
</file>